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2352E84-E907-4F2E-9E21-BDB2D42A13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1F4ABB1E-D065-4D37-9E40-403A43A7CC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1C5FC92-3CC0-42B1-AB88-3051B74CF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AD409-34CA-4A13-8681-1C841B6CFED2}" type="datetimeFigureOut">
              <a:rPr lang="en-ID" smtClean="0"/>
              <a:t>02/03/2021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EB3DA66-2246-4FBB-943B-F1D730D614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1D0262A-4B12-499F-9612-9A1C55251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EB57A-5422-40DD-A15A-6E6EBCB6125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487273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733E022-4FFF-45B3-BB12-C2CB0C4B85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AD9A094F-D808-4C42-BBE1-EB4EC61369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A1734EA-6B79-4F58-BA0C-6C17E0465E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AD409-34CA-4A13-8681-1C841B6CFED2}" type="datetimeFigureOut">
              <a:rPr lang="en-ID" smtClean="0"/>
              <a:t>02/03/2021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D02B8BE-0BA6-400D-9A5D-AF8F194C8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4E7BAB7-D920-4AFF-B0E2-4694CA5A3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EB57A-5422-40DD-A15A-6E6EBCB6125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321494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8D75A4CE-E6B6-4AB3-90BB-D59537DBA5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7FF3BFA1-E27E-469A-A995-5B32C6E731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B2E762A-CABB-4A11-95BA-B038500E7F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AD409-34CA-4A13-8681-1C841B6CFED2}" type="datetimeFigureOut">
              <a:rPr lang="en-ID" smtClean="0"/>
              <a:t>02/03/2021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C4F4316-0734-4CD8-994F-59FA22455E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A13E3CB-E71E-4A06-AE04-D10894350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EB57A-5422-40DD-A15A-6E6EBCB6125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1181532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AFA9355-B786-4B81-A9CA-1B437D8FAA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FB7C2F7-E303-4DEB-B74D-55EACD8262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3D1402F-7C9F-4148-B25C-1BB95E414E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AD409-34CA-4A13-8681-1C841B6CFED2}" type="datetimeFigureOut">
              <a:rPr lang="en-ID" smtClean="0"/>
              <a:t>02/03/2021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19DE071-46ED-429F-9B70-03313E0C86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89B88FC-1859-4D55-A68C-1F20048B6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EB57A-5422-40DD-A15A-6E6EBCB6125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017168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546C33A-84B0-4BBD-9C55-E2991ACA32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1C12D9F6-45F1-45FF-8845-D2B74FEA61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D8AAE05-394A-4EDD-AD2F-6DBFC76F5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AD409-34CA-4A13-8681-1C841B6CFED2}" type="datetimeFigureOut">
              <a:rPr lang="en-ID" smtClean="0"/>
              <a:t>02/03/2021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D1E27D2-97E5-4C78-82D5-C0765CD0E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0964B26-A8E6-4747-917A-DDADDC1CC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EB57A-5422-40DD-A15A-6E6EBCB6125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40221656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EF582D8-E884-434B-90D5-11B908861D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C2DFF357-7F5E-484B-9879-64745A21EC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1F4D8896-3F7A-4B02-8753-76A60A2E04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93C2326F-4810-4533-BF8B-16A4D2C344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AD409-34CA-4A13-8681-1C841B6CFED2}" type="datetimeFigureOut">
              <a:rPr lang="en-ID" smtClean="0"/>
              <a:t>02/03/2021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0AF36F3-6C76-4AE0-9603-1C1D3DE628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645B36F-B7E8-4FF4-B6C9-0191707BB6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EB57A-5422-40DD-A15A-6E6EBCB6125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6340121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AB16E5F-BA62-486A-A166-308A85CFE1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FE21734-3D09-4AD8-8F7E-F91DB564BD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C9D75A7-2CA2-4326-B6F0-224A8C74AD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DD5B96DB-047A-4970-8439-A9697A044C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990FBCFA-78EA-406C-A049-25C5A4E012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C5CC807F-F353-4BF3-A46B-65384F759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AD409-34CA-4A13-8681-1C841B6CFED2}" type="datetimeFigureOut">
              <a:rPr lang="en-ID" smtClean="0"/>
              <a:t>02/03/2021</a:t>
            </a:fld>
            <a:endParaRPr lang="en-ID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BA067F6E-8ACD-45D5-9DEB-83D39309A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0A840983-085C-44B7-B042-63D10B4B9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EB57A-5422-40DD-A15A-6E6EBCB6125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5418313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CA46C2F-DEB0-43DE-A21F-D0339A4D51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C737ECA3-CB81-465B-812F-EB5556A38C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AD409-34CA-4A13-8681-1C841B6CFED2}" type="datetimeFigureOut">
              <a:rPr lang="en-ID" smtClean="0"/>
              <a:t>02/03/2021</a:t>
            </a:fld>
            <a:endParaRPr lang="en-ID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843D3FBC-6E77-4F39-929F-AFF95DCED4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305E3F93-0D6B-4CAF-AFF6-43F5C656C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EB57A-5422-40DD-A15A-6E6EBCB6125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5833872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F0D13C17-F153-40AC-B444-77B5A8CEA6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AD409-34CA-4A13-8681-1C841B6CFED2}" type="datetimeFigureOut">
              <a:rPr lang="en-ID" smtClean="0"/>
              <a:t>02/03/2021</a:t>
            </a:fld>
            <a:endParaRPr lang="en-ID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202D95C9-EB82-4357-8B50-DEBA83FB44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C4199ABF-719F-4336-B9DE-70492DA526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EB57A-5422-40DD-A15A-6E6EBCB6125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654112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15614E7-450D-46BA-AE77-1EB5FA4699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E947E6C-F5A8-4CA3-A641-383264704C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034496D2-AB84-4195-98AA-8B098CEB08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2952EAFF-3F1F-4D66-B54D-DE0142212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AD409-34CA-4A13-8681-1C841B6CFED2}" type="datetimeFigureOut">
              <a:rPr lang="en-ID" smtClean="0"/>
              <a:t>02/03/2021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FBA6032A-D122-4ADB-8E3B-EBF3064C2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FCD09FDB-9F0E-41F8-869A-8ACD71ABB8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EB57A-5422-40DD-A15A-6E6EBCB6125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497867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C191BB8-F2BD-47F1-9BF5-C24BD9E256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C2FD8D19-26EE-4F6E-B07C-ACDCDEEFDE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48CA1CDF-4BED-4F15-9A70-3AB64D9A7B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563D18A-3B09-4B45-B903-90B7316289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AD409-34CA-4A13-8681-1C841B6CFED2}" type="datetimeFigureOut">
              <a:rPr lang="en-ID" smtClean="0"/>
              <a:t>02/03/2021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54ED95E-4B94-4CD2-8146-1FE591EED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8B4A7FD-63C6-411B-A4C8-A56456E8E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EB57A-5422-40DD-A15A-6E6EBCB6125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148171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7FB7591E-C3B6-48DD-AABC-46FE248458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28BA4314-C8F6-4733-9272-9EA3D8933D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BD40E0D-5DB3-4177-8966-510EF8A91A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2AD409-34CA-4A13-8681-1C841B6CFED2}" type="datetimeFigureOut">
              <a:rPr lang="en-ID" smtClean="0"/>
              <a:t>02/03/2021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F586FCB-D9CC-4540-AFC3-FD1341146A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901C667-A8B0-4034-A3D4-F6D87E3F66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6EB57A-5422-40DD-A15A-6E6EBCB61254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28984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 descr="Chart, scatter chart&#10;&#10;Description automatically generated">
            <a:extLst>
              <a:ext uri="{FF2B5EF4-FFF2-40B4-BE49-F238E27FC236}">
                <a16:creationId xmlns:a16="http://schemas.microsoft.com/office/drawing/2014/main" xmlns="" id="{F7557C2F-D4F2-4438-8CEA-7A453EFB5A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4838" y="636873"/>
            <a:ext cx="5962650" cy="4772025"/>
          </a:xfrm>
          <a:prstGeom prst="rect">
            <a:avLst/>
          </a:prstGeom>
        </p:spPr>
      </p:pic>
      <p:pic>
        <p:nvPicPr>
          <p:cNvPr id="17" name="Picture 16" descr="Chart, scatter chart&#10;&#10;Description automatically generated">
            <a:extLst>
              <a:ext uri="{FF2B5EF4-FFF2-40B4-BE49-F238E27FC236}">
                <a16:creationId xmlns:a16="http://schemas.microsoft.com/office/drawing/2014/main" xmlns="" id="{EB66A4AD-3E39-4A31-A854-AB056387137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676" y="630237"/>
            <a:ext cx="5962650" cy="4772025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F406D714-5BD3-43CA-A92E-23F4FB0175DC}"/>
              </a:ext>
            </a:extLst>
          </p:cNvPr>
          <p:cNvSpPr txBox="1"/>
          <p:nvPr/>
        </p:nvSpPr>
        <p:spPr>
          <a:xfrm>
            <a:off x="7974966" y="5116510"/>
            <a:ext cx="2204720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300" b="1" dirty="0"/>
              <a:t>log</a:t>
            </a:r>
            <a:r>
              <a:rPr lang="en-US" sz="1300" b="1" baseline="-25000" dirty="0"/>
              <a:t>10</a:t>
            </a:r>
            <a:r>
              <a:rPr lang="en-US" sz="1300" b="1" dirty="0"/>
              <a:t> of </a:t>
            </a:r>
            <a:r>
              <a:rPr lang="en-US" sz="1300" b="1" i="1" dirty="0"/>
              <a:t>pvs25</a:t>
            </a:r>
            <a:r>
              <a:rPr lang="en-US" sz="1300" b="1" dirty="0"/>
              <a:t> transcripts/µL</a:t>
            </a:r>
            <a:endParaRPr lang="en-ID" sz="13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6127F0FA-D16C-4677-B95F-3908B8D0D876}"/>
              </a:ext>
            </a:extLst>
          </p:cNvPr>
          <p:cNvSpPr txBox="1"/>
          <p:nvPr/>
        </p:nvSpPr>
        <p:spPr>
          <a:xfrm>
            <a:off x="2152650" y="5116510"/>
            <a:ext cx="2680335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300" b="1" dirty="0"/>
              <a:t>log</a:t>
            </a:r>
            <a:r>
              <a:rPr lang="en-US" sz="1300" b="1" baseline="-25000" dirty="0"/>
              <a:t>10</a:t>
            </a:r>
            <a:r>
              <a:rPr lang="en-US" sz="1300" b="1" dirty="0"/>
              <a:t> of </a:t>
            </a:r>
            <a:r>
              <a:rPr lang="en-US" sz="1300" b="1" i="1" dirty="0"/>
              <a:t>pfs25</a:t>
            </a:r>
            <a:r>
              <a:rPr lang="en-US" sz="1300" b="1" dirty="0"/>
              <a:t> transcripts/µL</a:t>
            </a:r>
            <a:endParaRPr lang="en-ID" sz="13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7C1146E0-4DAB-469B-80A5-FD46DCF71C99}"/>
              </a:ext>
            </a:extLst>
          </p:cNvPr>
          <p:cNvSpPr txBox="1"/>
          <p:nvPr/>
        </p:nvSpPr>
        <p:spPr>
          <a:xfrm rot="16200000">
            <a:off x="-863627" y="2257425"/>
            <a:ext cx="2680335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300" b="1" dirty="0"/>
              <a:t>log</a:t>
            </a:r>
            <a:r>
              <a:rPr lang="en-US" sz="1300" b="1" baseline="-25000" dirty="0"/>
              <a:t>10</a:t>
            </a:r>
            <a:r>
              <a:rPr lang="en-US" sz="1300" b="1" dirty="0"/>
              <a:t> of </a:t>
            </a:r>
            <a:r>
              <a:rPr lang="en-US" sz="1300" b="1" dirty="0" smtClean="0"/>
              <a:t>Pf gametocytes/µL</a:t>
            </a:r>
            <a:endParaRPr lang="en-ID" sz="13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F6E7C07D-BE07-4794-BC07-74204D971633}"/>
              </a:ext>
            </a:extLst>
          </p:cNvPr>
          <p:cNvSpPr txBox="1"/>
          <p:nvPr/>
        </p:nvSpPr>
        <p:spPr>
          <a:xfrm rot="16200000">
            <a:off x="4943159" y="2257424"/>
            <a:ext cx="2680335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300" b="1" dirty="0"/>
              <a:t>log</a:t>
            </a:r>
            <a:r>
              <a:rPr lang="en-US" sz="1300" b="1" baseline="-25000" dirty="0"/>
              <a:t>10</a:t>
            </a:r>
            <a:r>
              <a:rPr lang="en-US" sz="1300" b="1" dirty="0"/>
              <a:t> of </a:t>
            </a:r>
            <a:r>
              <a:rPr lang="en-US" sz="1300" b="1" dirty="0" err="1" smtClean="0"/>
              <a:t>Pv</a:t>
            </a:r>
            <a:r>
              <a:rPr lang="en-US" sz="1300" b="1" dirty="0" smtClean="0"/>
              <a:t> gametocytes/µL</a:t>
            </a:r>
            <a:endParaRPr lang="en-ID" sz="13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41767B1F-4B72-4B45-8790-CD175656EB9F}"/>
              </a:ext>
            </a:extLst>
          </p:cNvPr>
          <p:cNvSpPr txBox="1"/>
          <p:nvPr/>
        </p:nvSpPr>
        <p:spPr>
          <a:xfrm>
            <a:off x="330346" y="171450"/>
            <a:ext cx="5078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  <a:endParaRPr lang="en-ID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95F696E1-7A7C-40AC-9E4E-CDA05777A6A3}"/>
              </a:ext>
            </a:extLst>
          </p:cNvPr>
          <p:cNvSpPr txBox="1"/>
          <p:nvPr/>
        </p:nvSpPr>
        <p:spPr>
          <a:xfrm>
            <a:off x="6283326" y="248995"/>
            <a:ext cx="5078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en-ID" b="1" dirty="0"/>
          </a:p>
        </p:txBody>
      </p:sp>
    </p:spTree>
    <p:extLst>
      <p:ext uri="{BB962C8B-B14F-4D97-AF65-F5344CB8AC3E}">
        <p14:creationId xmlns:p14="http://schemas.microsoft.com/office/powerpoint/2010/main" val="21893695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</TotalTime>
  <Words>18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leen Kosasih</dc:creator>
  <cp:lastModifiedBy>Ayleen Kosasih</cp:lastModifiedBy>
  <cp:revision>6</cp:revision>
  <dcterms:created xsi:type="dcterms:W3CDTF">2021-01-05T04:22:37Z</dcterms:created>
  <dcterms:modified xsi:type="dcterms:W3CDTF">2021-03-02T11:32:24Z</dcterms:modified>
</cp:coreProperties>
</file>